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IAO XL" initials="JX" lastIdx="1" clrIdx="0">
    <p:extLst>
      <p:ext uri="{19B8F6BF-5375-455C-9EA6-DF929625EA0E}">
        <p15:presenceInfo xmlns:p15="http://schemas.microsoft.com/office/powerpoint/2012/main" userId="8e12c6f478ff0015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5082" autoAdjust="0"/>
  </p:normalViewPr>
  <p:slideViewPr>
    <p:cSldViewPr snapToGrid="0">
      <p:cViewPr>
        <p:scale>
          <a:sx n="200" d="100"/>
          <a:sy n="200" d="100"/>
        </p:scale>
        <p:origin x="115" y="-323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hq!$A$10:$A$149</c:f>
              <c:numCache>
                <c:formatCode>General</c:formatCode>
                <c:ptCount val="140"/>
                <c:pt idx="0">
                  <c:v>10</c:v>
                </c:pt>
                <c:pt idx="1">
                  <c:v>11</c:v>
                </c:pt>
                <c:pt idx="2">
                  <c:v>12</c:v>
                </c:pt>
                <c:pt idx="3">
                  <c:v>13</c:v>
                </c:pt>
                <c:pt idx="4">
                  <c:v>14</c:v>
                </c:pt>
                <c:pt idx="5">
                  <c:v>15</c:v>
                </c:pt>
                <c:pt idx="6">
                  <c:v>16</c:v>
                </c:pt>
                <c:pt idx="7">
                  <c:v>17</c:v>
                </c:pt>
                <c:pt idx="8">
                  <c:v>18</c:v>
                </c:pt>
                <c:pt idx="9">
                  <c:v>19</c:v>
                </c:pt>
                <c:pt idx="10">
                  <c:v>20</c:v>
                </c:pt>
                <c:pt idx="11">
                  <c:v>21</c:v>
                </c:pt>
                <c:pt idx="12">
                  <c:v>22</c:v>
                </c:pt>
                <c:pt idx="13">
                  <c:v>23</c:v>
                </c:pt>
                <c:pt idx="14">
                  <c:v>24</c:v>
                </c:pt>
                <c:pt idx="15">
                  <c:v>25</c:v>
                </c:pt>
                <c:pt idx="16">
                  <c:v>26</c:v>
                </c:pt>
                <c:pt idx="17">
                  <c:v>27</c:v>
                </c:pt>
                <c:pt idx="18">
                  <c:v>28</c:v>
                </c:pt>
                <c:pt idx="19">
                  <c:v>29</c:v>
                </c:pt>
                <c:pt idx="20">
                  <c:v>30</c:v>
                </c:pt>
                <c:pt idx="21">
                  <c:v>31</c:v>
                </c:pt>
                <c:pt idx="22">
                  <c:v>32</c:v>
                </c:pt>
                <c:pt idx="23">
                  <c:v>33</c:v>
                </c:pt>
                <c:pt idx="24">
                  <c:v>34</c:v>
                </c:pt>
                <c:pt idx="25">
                  <c:v>35</c:v>
                </c:pt>
                <c:pt idx="26">
                  <c:v>36</c:v>
                </c:pt>
                <c:pt idx="27">
                  <c:v>37</c:v>
                </c:pt>
                <c:pt idx="28">
                  <c:v>38</c:v>
                </c:pt>
                <c:pt idx="29">
                  <c:v>39</c:v>
                </c:pt>
                <c:pt idx="30">
                  <c:v>40</c:v>
                </c:pt>
                <c:pt idx="31">
                  <c:v>41</c:v>
                </c:pt>
                <c:pt idx="32">
                  <c:v>42</c:v>
                </c:pt>
                <c:pt idx="33">
                  <c:v>43</c:v>
                </c:pt>
                <c:pt idx="34">
                  <c:v>44</c:v>
                </c:pt>
                <c:pt idx="35">
                  <c:v>45</c:v>
                </c:pt>
                <c:pt idx="36">
                  <c:v>46</c:v>
                </c:pt>
                <c:pt idx="37">
                  <c:v>47</c:v>
                </c:pt>
                <c:pt idx="38">
                  <c:v>48</c:v>
                </c:pt>
                <c:pt idx="39">
                  <c:v>49</c:v>
                </c:pt>
                <c:pt idx="40">
                  <c:v>50</c:v>
                </c:pt>
                <c:pt idx="41">
                  <c:v>51</c:v>
                </c:pt>
                <c:pt idx="42">
                  <c:v>52</c:v>
                </c:pt>
                <c:pt idx="43">
                  <c:v>53</c:v>
                </c:pt>
                <c:pt idx="44">
                  <c:v>54</c:v>
                </c:pt>
                <c:pt idx="45">
                  <c:v>55</c:v>
                </c:pt>
                <c:pt idx="46">
                  <c:v>56</c:v>
                </c:pt>
                <c:pt idx="47">
                  <c:v>57</c:v>
                </c:pt>
                <c:pt idx="48">
                  <c:v>58</c:v>
                </c:pt>
                <c:pt idx="49">
                  <c:v>59</c:v>
                </c:pt>
                <c:pt idx="50">
                  <c:v>60</c:v>
                </c:pt>
                <c:pt idx="51">
                  <c:v>61</c:v>
                </c:pt>
                <c:pt idx="52">
                  <c:v>62</c:v>
                </c:pt>
                <c:pt idx="53">
                  <c:v>63</c:v>
                </c:pt>
                <c:pt idx="54">
                  <c:v>64</c:v>
                </c:pt>
                <c:pt idx="55">
                  <c:v>65</c:v>
                </c:pt>
                <c:pt idx="56">
                  <c:v>66</c:v>
                </c:pt>
                <c:pt idx="57">
                  <c:v>67</c:v>
                </c:pt>
                <c:pt idx="58">
                  <c:v>68</c:v>
                </c:pt>
                <c:pt idx="59">
                  <c:v>69</c:v>
                </c:pt>
                <c:pt idx="60">
                  <c:v>70</c:v>
                </c:pt>
                <c:pt idx="61">
                  <c:v>71</c:v>
                </c:pt>
                <c:pt idx="62">
                  <c:v>72</c:v>
                </c:pt>
                <c:pt idx="63">
                  <c:v>73</c:v>
                </c:pt>
                <c:pt idx="64">
                  <c:v>74</c:v>
                </c:pt>
                <c:pt idx="65">
                  <c:v>75</c:v>
                </c:pt>
                <c:pt idx="66">
                  <c:v>76</c:v>
                </c:pt>
                <c:pt idx="67">
                  <c:v>77</c:v>
                </c:pt>
                <c:pt idx="68">
                  <c:v>78</c:v>
                </c:pt>
                <c:pt idx="69">
                  <c:v>79</c:v>
                </c:pt>
                <c:pt idx="70">
                  <c:v>80</c:v>
                </c:pt>
                <c:pt idx="71">
                  <c:v>81</c:v>
                </c:pt>
                <c:pt idx="72">
                  <c:v>82</c:v>
                </c:pt>
                <c:pt idx="73">
                  <c:v>83</c:v>
                </c:pt>
                <c:pt idx="74">
                  <c:v>84</c:v>
                </c:pt>
                <c:pt idx="75">
                  <c:v>85</c:v>
                </c:pt>
                <c:pt idx="76">
                  <c:v>86</c:v>
                </c:pt>
                <c:pt idx="77">
                  <c:v>87</c:v>
                </c:pt>
                <c:pt idx="78">
                  <c:v>88</c:v>
                </c:pt>
                <c:pt idx="79">
                  <c:v>89</c:v>
                </c:pt>
                <c:pt idx="80">
                  <c:v>90</c:v>
                </c:pt>
                <c:pt idx="81">
                  <c:v>91</c:v>
                </c:pt>
                <c:pt idx="82">
                  <c:v>92</c:v>
                </c:pt>
                <c:pt idx="83">
                  <c:v>93</c:v>
                </c:pt>
                <c:pt idx="84">
                  <c:v>94</c:v>
                </c:pt>
                <c:pt idx="85">
                  <c:v>95</c:v>
                </c:pt>
                <c:pt idx="86">
                  <c:v>96</c:v>
                </c:pt>
                <c:pt idx="87">
                  <c:v>97</c:v>
                </c:pt>
                <c:pt idx="88">
                  <c:v>98</c:v>
                </c:pt>
                <c:pt idx="89">
                  <c:v>99</c:v>
                </c:pt>
                <c:pt idx="90">
                  <c:v>100</c:v>
                </c:pt>
                <c:pt idx="91">
                  <c:v>101</c:v>
                </c:pt>
                <c:pt idx="92">
                  <c:v>102</c:v>
                </c:pt>
                <c:pt idx="93">
                  <c:v>103</c:v>
                </c:pt>
                <c:pt idx="94">
                  <c:v>104</c:v>
                </c:pt>
                <c:pt idx="95">
                  <c:v>105</c:v>
                </c:pt>
                <c:pt idx="96">
                  <c:v>106</c:v>
                </c:pt>
                <c:pt idx="97">
                  <c:v>107</c:v>
                </c:pt>
                <c:pt idx="98">
                  <c:v>108</c:v>
                </c:pt>
                <c:pt idx="99">
                  <c:v>109</c:v>
                </c:pt>
                <c:pt idx="100">
                  <c:v>110</c:v>
                </c:pt>
                <c:pt idx="101">
                  <c:v>111</c:v>
                </c:pt>
                <c:pt idx="102">
                  <c:v>112</c:v>
                </c:pt>
                <c:pt idx="103">
                  <c:v>113</c:v>
                </c:pt>
                <c:pt idx="104">
                  <c:v>114</c:v>
                </c:pt>
                <c:pt idx="105">
                  <c:v>115</c:v>
                </c:pt>
                <c:pt idx="106">
                  <c:v>116</c:v>
                </c:pt>
                <c:pt idx="107">
                  <c:v>117</c:v>
                </c:pt>
                <c:pt idx="108">
                  <c:v>118</c:v>
                </c:pt>
                <c:pt idx="109">
                  <c:v>119</c:v>
                </c:pt>
                <c:pt idx="110">
                  <c:v>120</c:v>
                </c:pt>
                <c:pt idx="111">
                  <c:v>121</c:v>
                </c:pt>
                <c:pt idx="112">
                  <c:v>122</c:v>
                </c:pt>
                <c:pt idx="113">
                  <c:v>123</c:v>
                </c:pt>
                <c:pt idx="114">
                  <c:v>124</c:v>
                </c:pt>
                <c:pt idx="115">
                  <c:v>125</c:v>
                </c:pt>
                <c:pt idx="116">
                  <c:v>126</c:v>
                </c:pt>
                <c:pt idx="117">
                  <c:v>127</c:v>
                </c:pt>
                <c:pt idx="118">
                  <c:v>128</c:v>
                </c:pt>
                <c:pt idx="119">
                  <c:v>129</c:v>
                </c:pt>
                <c:pt idx="120">
                  <c:v>130</c:v>
                </c:pt>
                <c:pt idx="121">
                  <c:v>131</c:v>
                </c:pt>
                <c:pt idx="122">
                  <c:v>132</c:v>
                </c:pt>
                <c:pt idx="123">
                  <c:v>133</c:v>
                </c:pt>
                <c:pt idx="124">
                  <c:v>134</c:v>
                </c:pt>
                <c:pt idx="125">
                  <c:v>135</c:v>
                </c:pt>
                <c:pt idx="126">
                  <c:v>136</c:v>
                </c:pt>
                <c:pt idx="127">
                  <c:v>137</c:v>
                </c:pt>
                <c:pt idx="128">
                  <c:v>138</c:v>
                </c:pt>
                <c:pt idx="129">
                  <c:v>139</c:v>
                </c:pt>
                <c:pt idx="130">
                  <c:v>140</c:v>
                </c:pt>
                <c:pt idx="131">
                  <c:v>141</c:v>
                </c:pt>
                <c:pt idx="132">
                  <c:v>142</c:v>
                </c:pt>
                <c:pt idx="133">
                  <c:v>143</c:v>
                </c:pt>
                <c:pt idx="134">
                  <c:v>144</c:v>
                </c:pt>
                <c:pt idx="135">
                  <c:v>145</c:v>
                </c:pt>
                <c:pt idx="136">
                  <c:v>146</c:v>
                </c:pt>
                <c:pt idx="137">
                  <c:v>147</c:v>
                </c:pt>
                <c:pt idx="138">
                  <c:v>148</c:v>
                </c:pt>
                <c:pt idx="139">
                  <c:v>149</c:v>
                </c:pt>
              </c:numCache>
            </c:numRef>
          </c:xVal>
          <c:yVal>
            <c:numRef>
              <c:f>hq!$B$10:$B$149</c:f>
              <c:numCache>
                <c:formatCode>General</c:formatCode>
                <c:ptCount val="140"/>
                <c:pt idx="0">
                  <c:v>4080452</c:v>
                </c:pt>
                <c:pt idx="1">
                  <c:v>3261510</c:v>
                </c:pt>
                <c:pt idx="2">
                  <c:v>2661050</c:v>
                </c:pt>
                <c:pt idx="3">
                  <c:v>2209441</c:v>
                </c:pt>
                <c:pt idx="4">
                  <c:v>1913675</c:v>
                </c:pt>
                <c:pt idx="5">
                  <c:v>1716520</c:v>
                </c:pt>
                <c:pt idx="6">
                  <c:v>1609834</c:v>
                </c:pt>
                <c:pt idx="7">
                  <c:v>1581454</c:v>
                </c:pt>
                <c:pt idx="8">
                  <c:v>1600275</c:v>
                </c:pt>
                <c:pt idx="9">
                  <c:v>1669285</c:v>
                </c:pt>
                <c:pt idx="10">
                  <c:v>1768349</c:v>
                </c:pt>
                <c:pt idx="11">
                  <c:v>1892315</c:v>
                </c:pt>
                <c:pt idx="12">
                  <c:v>2035462</c:v>
                </c:pt>
                <c:pt idx="13">
                  <c:v>2183164</c:v>
                </c:pt>
                <c:pt idx="14">
                  <c:v>2330699</c:v>
                </c:pt>
                <c:pt idx="15">
                  <c:v>2474755</c:v>
                </c:pt>
                <c:pt idx="16">
                  <c:v>2609909</c:v>
                </c:pt>
                <c:pt idx="17">
                  <c:v>2719348</c:v>
                </c:pt>
                <c:pt idx="18">
                  <c:v>2801962</c:v>
                </c:pt>
                <c:pt idx="19">
                  <c:v>2867868</c:v>
                </c:pt>
                <c:pt idx="20">
                  <c:v>2911496</c:v>
                </c:pt>
                <c:pt idx="21">
                  <c:v>2928350</c:v>
                </c:pt>
                <c:pt idx="22">
                  <c:v>2928328</c:v>
                </c:pt>
                <c:pt idx="23">
                  <c:v>2902680</c:v>
                </c:pt>
                <c:pt idx="24">
                  <c:v>2868269</c:v>
                </c:pt>
                <c:pt idx="25">
                  <c:v>2810865</c:v>
                </c:pt>
                <c:pt idx="26">
                  <c:v>2748120</c:v>
                </c:pt>
                <c:pt idx="27">
                  <c:v>2677576</c:v>
                </c:pt>
                <c:pt idx="28">
                  <c:v>2595794</c:v>
                </c:pt>
                <c:pt idx="29">
                  <c:v>2521024</c:v>
                </c:pt>
                <c:pt idx="30">
                  <c:v>2437902</c:v>
                </c:pt>
                <c:pt idx="31">
                  <c:v>2360855</c:v>
                </c:pt>
                <c:pt idx="32">
                  <c:v>2288888</c:v>
                </c:pt>
                <c:pt idx="33">
                  <c:v>2232158</c:v>
                </c:pt>
                <c:pt idx="34">
                  <c:v>2172479</c:v>
                </c:pt>
                <c:pt idx="35">
                  <c:v>2133451</c:v>
                </c:pt>
                <c:pt idx="36">
                  <c:v>2104391</c:v>
                </c:pt>
                <c:pt idx="37">
                  <c:v>2088046</c:v>
                </c:pt>
                <c:pt idx="38">
                  <c:v>2084098</c:v>
                </c:pt>
                <c:pt idx="39">
                  <c:v>2098633</c:v>
                </c:pt>
                <c:pt idx="40">
                  <c:v>2130757</c:v>
                </c:pt>
                <c:pt idx="41">
                  <c:v>2174658</c:v>
                </c:pt>
                <c:pt idx="42">
                  <c:v>2233869</c:v>
                </c:pt>
                <c:pt idx="43">
                  <c:v>2313043</c:v>
                </c:pt>
                <c:pt idx="44">
                  <c:v>2405103</c:v>
                </c:pt>
                <c:pt idx="45">
                  <c:v>2500262</c:v>
                </c:pt>
                <c:pt idx="46">
                  <c:v>2618798</c:v>
                </c:pt>
                <c:pt idx="47">
                  <c:v>2744421</c:v>
                </c:pt>
                <c:pt idx="48">
                  <c:v>2869747</c:v>
                </c:pt>
                <c:pt idx="49">
                  <c:v>3004323</c:v>
                </c:pt>
                <c:pt idx="50">
                  <c:v>3148620</c:v>
                </c:pt>
                <c:pt idx="51">
                  <c:v>3278963</c:v>
                </c:pt>
                <c:pt idx="52">
                  <c:v>3416183</c:v>
                </c:pt>
                <c:pt idx="53">
                  <c:v>3538465</c:v>
                </c:pt>
                <c:pt idx="54">
                  <c:v>3658075</c:v>
                </c:pt>
                <c:pt idx="55">
                  <c:v>3770287</c:v>
                </c:pt>
                <c:pt idx="56">
                  <c:v>3866986</c:v>
                </c:pt>
                <c:pt idx="57">
                  <c:v>3948017</c:v>
                </c:pt>
                <c:pt idx="58">
                  <c:v>4007925</c:v>
                </c:pt>
                <c:pt idx="59">
                  <c:v>4057801</c:v>
                </c:pt>
                <c:pt idx="60">
                  <c:v>4084433</c:v>
                </c:pt>
                <c:pt idx="61">
                  <c:v>4097114</c:v>
                </c:pt>
                <c:pt idx="62">
                  <c:v>4087450</c:v>
                </c:pt>
                <c:pt idx="63">
                  <c:v>4059538</c:v>
                </c:pt>
                <c:pt idx="64">
                  <c:v>4009439</c:v>
                </c:pt>
                <c:pt idx="65">
                  <c:v>3944206</c:v>
                </c:pt>
                <c:pt idx="66">
                  <c:v>3860896</c:v>
                </c:pt>
                <c:pt idx="67">
                  <c:v>3769188</c:v>
                </c:pt>
                <c:pt idx="68">
                  <c:v>3654671</c:v>
                </c:pt>
                <c:pt idx="69">
                  <c:v>3526754</c:v>
                </c:pt>
                <c:pt idx="70">
                  <c:v>3389841</c:v>
                </c:pt>
                <c:pt idx="71">
                  <c:v>3251732</c:v>
                </c:pt>
                <c:pt idx="72">
                  <c:v>3100256</c:v>
                </c:pt>
                <c:pt idx="73">
                  <c:v>2943269</c:v>
                </c:pt>
                <c:pt idx="74">
                  <c:v>2787689</c:v>
                </c:pt>
                <c:pt idx="75">
                  <c:v>2625721</c:v>
                </c:pt>
                <c:pt idx="76">
                  <c:v>2464143</c:v>
                </c:pt>
                <c:pt idx="77">
                  <c:v>2309232</c:v>
                </c:pt>
                <c:pt idx="78">
                  <c:v>2151819</c:v>
                </c:pt>
                <c:pt idx="79">
                  <c:v>2000371</c:v>
                </c:pt>
                <c:pt idx="80">
                  <c:v>1852095</c:v>
                </c:pt>
                <c:pt idx="81">
                  <c:v>1713659</c:v>
                </c:pt>
                <c:pt idx="82">
                  <c:v>1582062</c:v>
                </c:pt>
                <c:pt idx="83">
                  <c:v>1456854</c:v>
                </c:pt>
                <c:pt idx="84">
                  <c:v>1340680</c:v>
                </c:pt>
                <c:pt idx="85">
                  <c:v>1230803</c:v>
                </c:pt>
                <c:pt idx="86">
                  <c:v>1121423</c:v>
                </c:pt>
                <c:pt idx="87">
                  <c:v>1025450</c:v>
                </c:pt>
                <c:pt idx="88">
                  <c:v>937605</c:v>
                </c:pt>
                <c:pt idx="89">
                  <c:v>857367</c:v>
                </c:pt>
                <c:pt idx="90">
                  <c:v>781692</c:v>
                </c:pt>
                <c:pt idx="91">
                  <c:v>716049</c:v>
                </c:pt>
                <c:pt idx="92">
                  <c:v>652734</c:v>
                </c:pt>
                <c:pt idx="93">
                  <c:v>599594</c:v>
                </c:pt>
                <c:pt idx="94">
                  <c:v>547968</c:v>
                </c:pt>
                <c:pt idx="95">
                  <c:v>503263</c:v>
                </c:pt>
                <c:pt idx="96">
                  <c:v>464365</c:v>
                </c:pt>
                <c:pt idx="97">
                  <c:v>427827</c:v>
                </c:pt>
                <c:pt idx="98">
                  <c:v>397998</c:v>
                </c:pt>
                <c:pt idx="99">
                  <c:v>370686</c:v>
                </c:pt>
                <c:pt idx="100">
                  <c:v>346774</c:v>
                </c:pt>
                <c:pt idx="101">
                  <c:v>326453</c:v>
                </c:pt>
                <c:pt idx="102">
                  <c:v>308323</c:v>
                </c:pt>
                <c:pt idx="103">
                  <c:v>291296</c:v>
                </c:pt>
                <c:pt idx="104">
                  <c:v>277937</c:v>
                </c:pt>
                <c:pt idx="105">
                  <c:v>265368</c:v>
                </c:pt>
                <c:pt idx="106">
                  <c:v>253501</c:v>
                </c:pt>
                <c:pt idx="107">
                  <c:v>244193</c:v>
                </c:pt>
                <c:pt idx="108">
                  <c:v>234701</c:v>
                </c:pt>
                <c:pt idx="109">
                  <c:v>227207</c:v>
                </c:pt>
                <c:pt idx="110">
                  <c:v>221577</c:v>
                </c:pt>
                <c:pt idx="111">
                  <c:v>215394</c:v>
                </c:pt>
                <c:pt idx="112">
                  <c:v>211028</c:v>
                </c:pt>
                <c:pt idx="113">
                  <c:v>205822</c:v>
                </c:pt>
                <c:pt idx="114">
                  <c:v>202232</c:v>
                </c:pt>
                <c:pt idx="115">
                  <c:v>199067</c:v>
                </c:pt>
                <c:pt idx="116">
                  <c:v>194956</c:v>
                </c:pt>
                <c:pt idx="117">
                  <c:v>192200</c:v>
                </c:pt>
                <c:pt idx="118">
                  <c:v>189245</c:v>
                </c:pt>
                <c:pt idx="119">
                  <c:v>187827</c:v>
                </c:pt>
                <c:pt idx="120">
                  <c:v>185386</c:v>
                </c:pt>
                <c:pt idx="121">
                  <c:v>182708</c:v>
                </c:pt>
                <c:pt idx="122">
                  <c:v>180549</c:v>
                </c:pt>
                <c:pt idx="123">
                  <c:v>178990</c:v>
                </c:pt>
                <c:pt idx="124">
                  <c:v>178206</c:v>
                </c:pt>
                <c:pt idx="125">
                  <c:v>175802</c:v>
                </c:pt>
                <c:pt idx="126">
                  <c:v>174495</c:v>
                </c:pt>
                <c:pt idx="127">
                  <c:v>173257</c:v>
                </c:pt>
                <c:pt idx="128">
                  <c:v>171785</c:v>
                </c:pt>
                <c:pt idx="129">
                  <c:v>168751</c:v>
                </c:pt>
                <c:pt idx="130">
                  <c:v>167488</c:v>
                </c:pt>
                <c:pt idx="131">
                  <c:v>166123</c:v>
                </c:pt>
                <c:pt idx="132">
                  <c:v>164089</c:v>
                </c:pt>
                <c:pt idx="133">
                  <c:v>162352</c:v>
                </c:pt>
                <c:pt idx="134">
                  <c:v>159833</c:v>
                </c:pt>
                <c:pt idx="135">
                  <c:v>157677</c:v>
                </c:pt>
                <c:pt idx="136">
                  <c:v>156757</c:v>
                </c:pt>
                <c:pt idx="137">
                  <c:v>154280</c:v>
                </c:pt>
                <c:pt idx="138">
                  <c:v>152839</c:v>
                </c:pt>
                <c:pt idx="139">
                  <c:v>15077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BB45-4E2B-974B-C6B13A583663}"/>
            </c:ext>
          </c:extLst>
        </c:ser>
        <c:ser>
          <c:idx val="1"/>
          <c:order val="1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hq!$A$10:$A$149</c:f>
              <c:numCache>
                <c:formatCode>General</c:formatCode>
                <c:ptCount val="140"/>
                <c:pt idx="0">
                  <c:v>10</c:v>
                </c:pt>
                <c:pt idx="1">
                  <c:v>11</c:v>
                </c:pt>
                <c:pt idx="2">
                  <c:v>12</c:v>
                </c:pt>
                <c:pt idx="3">
                  <c:v>13</c:v>
                </c:pt>
                <c:pt idx="4">
                  <c:v>14</c:v>
                </c:pt>
                <c:pt idx="5">
                  <c:v>15</c:v>
                </c:pt>
                <c:pt idx="6">
                  <c:v>16</c:v>
                </c:pt>
                <c:pt idx="7">
                  <c:v>17</c:v>
                </c:pt>
                <c:pt idx="8">
                  <c:v>18</c:v>
                </c:pt>
                <c:pt idx="9">
                  <c:v>19</c:v>
                </c:pt>
                <c:pt idx="10">
                  <c:v>20</c:v>
                </c:pt>
                <c:pt idx="11">
                  <c:v>21</c:v>
                </c:pt>
                <c:pt idx="12">
                  <c:v>22</c:v>
                </c:pt>
                <c:pt idx="13">
                  <c:v>23</c:v>
                </c:pt>
                <c:pt idx="14">
                  <c:v>24</c:v>
                </c:pt>
                <c:pt idx="15">
                  <c:v>25</c:v>
                </c:pt>
                <c:pt idx="16">
                  <c:v>26</c:v>
                </c:pt>
                <c:pt idx="17">
                  <c:v>27</c:v>
                </c:pt>
                <c:pt idx="18">
                  <c:v>28</c:v>
                </c:pt>
                <c:pt idx="19">
                  <c:v>29</c:v>
                </c:pt>
                <c:pt idx="20">
                  <c:v>30</c:v>
                </c:pt>
                <c:pt idx="21">
                  <c:v>31</c:v>
                </c:pt>
                <c:pt idx="22">
                  <c:v>32</c:v>
                </c:pt>
                <c:pt idx="23">
                  <c:v>33</c:v>
                </c:pt>
                <c:pt idx="24">
                  <c:v>34</c:v>
                </c:pt>
                <c:pt idx="25">
                  <c:v>35</c:v>
                </c:pt>
                <c:pt idx="26">
                  <c:v>36</c:v>
                </c:pt>
                <c:pt idx="27">
                  <c:v>37</c:v>
                </c:pt>
                <c:pt idx="28">
                  <c:v>38</c:v>
                </c:pt>
                <c:pt idx="29">
                  <c:v>39</c:v>
                </c:pt>
                <c:pt idx="30">
                  <c:v>40</c:v>
                </c:pt>
                <c:pt idx="31">
                  <c:v>41</c:v>
                </c:pt>
                <c:pt idx="32">
                  <c:v>42</c:v>
                </c:pt>
                <c:pt idx="33">
                  <c:v>43</c:v>
                </c:pt>
                <c:pt idx="34">
                  <c:v>44</c:v>
                </c:pt>
                <c:pt idx="35">
                  <c:v>45</c:v>
                </c:pt>
                <c:pt idx="36">
                  <c:v>46</c:v>
                </c:pt>
                <c:pt idx="37">
                  <c:v>47</c:v>
                </c:pt>
                <c:pt idx="38">
                  <c:v>48</c:v>
                </c:pt>
                <c:pt idx="39">
                  <c:v>49</c:v>
                </c:pt>
                <c:pt idx="40">
                  <c:v>50</c:v>
                </c:pt>
                <c:pt idx="41">
                  <c:v>51</c:v>
                </c:pt>
                <c:pt idx="42">
                  <c:v>52</c:v>
                </c:pt>
                <c:pt idx="43">
                  <c:v>53</c:v>
                </c:pt>
                <c:pt idx="44">
                  <c:v>54</c:v>
                </c:pt>
                <c:pt idx="45">
                  <c:v>55</c:v>
                </c:pt>
                <c:pt idx="46">
                  <c:v>56</c:v>
                </c:pt>
                <c:pt idx="47">
                  <c:v>57</c:v>
                </c:pt>
                <c:pt idx="48">
                  <c:v>58</c:v>
                </c:pt>
                <c:pt idx="49">
                  <c:v>59</c:v>
                </c:pt>
                <c:pt idx="50">
                  <c:v>60</c:v>
                </c:pt>
                <c:pt idx="51">
                  <c:v>61</c:v>
                </c:pt>
                <c:pt idx="52">
                  <c:v>62</c:v>
                </c:pt>
                <c:pt idx="53">
                  <c:v>63</c:v>
                </c:pt>
                <c:pt idx="54">
                  <c:v>64</c:v>
                </c:pt>
                <c:pt idx="55">
                  <c:v>65</c:v>
                </c:pt>
                <c:pt idx="56">
                  <c:v>66</c:v>
                </c:pt>
                <c:pt idx="57">
                  <c:v>67</c:v>
                </c:pt>
                <c:pt idx="58">
                  <c:v>68</c:v>
                </c:pt>
                <c:pt idx="59">
                  <c:v>69</c:v>
                </c:pt>
                <c:pt idx="60">
                  <c:v>70</c:v>
                </c:pt>
                <c:pt idx="61">
                  <c:v>71</c:v>
                </c:pt>
                <c:pt idx="62">
                  <c:v>72</c:v>
                </c:pt>
                <c:pt idx="63">
                  <c:v>73</c:v>
                </c:pt>
                <c:pt idx="64">
                  <c:v>74</c:v>
                </c:pt>
                <c:pt idx="65">
                  <c:v>75</c:v>
                </c:pt>
                <c:pt idx="66">
                  <c:v>76</c:v>
                </c:pt>
                <c:pt idx="67">
                  <c:v>77</c:v>
                </c:pt>
                <c:pt idx="68">
                  <c:v>78</c:v>
                </c:pt>
                <c:pt idx="69">
                  <c:v>79</c:v>
                </c:pt>
                <c:pt idx="70">
                  <c:v>80</c:v>
                </c:pt>
                <c:pt idx="71">
                  <c:v>81</c:v>
                </c:pt>
                <c:pt idx="72">
                  <c:v>82</c:v>
                </c:pt>
                <c:pt idx="73">
                  <c:v>83</c:v>
                </c:pt>
                <c:pt idx="74">
                  <c:v>84</c:v>
                </c:pt>
                <c:pt idx="75">
                  <c:v>85</c:v>
                </c:pt>
                <c:pt idx="76">
                  <c:v>86</c:v>
                </c:pt>
                <c:pt idx="77">
                  <c:v>87</c:v>
                </c:pt>
                <c:pt idx="78">
                  <c:v>88</c:v>
                </c:pt>
                <c:pt idx="79">
                  <c:v>89</c:v>
                </c:pt>
                <c:pt idx="80">
                  <c:v>90</c:v>
                </c:pt>
                <c:pt idx="81">
                  <c:v>91</c:v>
                </c:pt>
                <c:pt idx="82">
                  <c:v>92</c:v>
                </c:pt>
                <c:pt idx="83">
                  <c:v>93</c:v>
                </c:pt>
                <c:pt idx="84">
                  <c:v>94</c:v>
                </c:pt>
                <c:pt idx="85">
                  <c:v>95</c:v>
                </c:pt>
                <c:pt idx="86">
                  <c:v>96</c:v>
                </c:pt>
                <c:pt idx="87">
                  <c:v>97</c:v>
                </c:pt>
                <c:pt idx="88">
                  <c:v>98</c:v>
                </c:pt>
                <c:pt idx="89">
                  <c:v>99</c:v>
                </c:pt>
                <c:pt idx="90">
                  <c:v>100</c:v>
                </c:pt>
                <c:pt idx="91">
                  <c:v>101</c:v>
                </c:pt>
                <c:pt idx="92">
                  <c:v>102</c:v>
                </c:pt>
                <c:pt idx="93">
                  <c:v>103</c:v>
                </c:pt>
                <c:pt idx="94">
                  <c:v>104</c:v>
                </c:pt>
                <c:pt idx="95">
                  <c:v>105</c:v>
                </c:pt>
                <c:pt idx="96">
                  <c:v>106</c:v>
                </c:pt>
                <c:pt idx="97">
                  <c:v>107</c:v>
                </c:pt>
                <c:pt idx="98">
                  <c:v>108</c:v>
                </c:pt>
                <c:pt idx="99">
                  <c:v>109</c:v>
                </c:pt>
                <c:pt idx="100">
                  <c:v>110</c:v>
                </c:pt>
                <c:pt idx="101">
                  <c:v>111</c:v>
                </c:pt>
                <c:pt idx="102">
                  <c:v>112</c:v>
                </c:pt>
                <c:pt idx="103">
                  <c:v>113</c:v>
                </c:pt>
                <c:pt idx="104">
                  <c:v>114</c:v>
                </c:pt>
                <c:pt idx="105">
                  <c:v>115</c:v>
                </c:pt>
                <c:pt idx="106">
                  <c:v>116</c:v>
                </c:pt>
                <c:pt idx="107">
                  <c:v>117</c:v>
                </c:pt>
                <c:pt idx="108">
                  <c:v>118</c:v>
                </c:pt>
                <c:pt idx="109">
                  <c:v>119</c:v>
                </c:pt>
                <c:pt idx="110">
                  <c:v>120</c:v>
                </c:pt>
                <c:pt idx="111">
                  <c:v>121</c:v>
                </c:pt>
                <c:pt idx="112">
                  <c:v>122</c:v>
                </c:pt>
                <c:pt idx="113">
                  <c:v>123</c:v>
                </c:pt>
                <c:pt idx="114">
                  <c:v>124</c:v>
                </c:pt>
                <c:pt idx="115">
                  <c:v>125</c:v>
                </c:pt>
                <c:pt idx="116">
                  <c:v>126</c:v>
                </c:pt>
                <c:pt idx="117">
                  <c:v>127</c:v>
                </c:pt>
                <c:pt idx="118">
                  <c:v>128</c:v>
                </c:pt>
                <c:pt idx="119">
                  <c:v>129</c:v>
                </c:pt>
                <c:pt idx="120">
                  <c:v>130</c:v>
                </c:pt>
                <c:pt idx="121">
                  <c:v>131</c:v>
                </c:pt>
                <c:pt idx="122">
                  <c:v>132</c:v>
                </c:pt>
                <c:pt idx="123">
                  <c:v>133</c:v>
                </c:pt>
                <c:pt idx="124">
                  <c:v>134</c:v>
                </c:pt>
                <c:pt idx="125">
                  <c:v>135</c:v>
                </c:pt>
                <c:pt idx="126">
                  <c:v>136</c:v>
                </c:pt>
                <c:pt idx="127">
                  <c:v>137</c:v>
                </c:pt>
                <c:pt idx="128">
                  <c:v>138</c:v>
                </c:pt>
                <c:pt idx="129">
                  <c:v>139</c:v>
                </c:pt>
                <c:pt idx="130">
                  <c:v>140</c:v>
                </c:pt>
                <c:pt idx="131">
                  <c:v>141</c:v>
                </c:pt>
                <c:pt idx="132">
                  <c:v>142</c:v>
                </c:pt>
                <c:pt idx="133">
                  <c:v>143</c:v>
                </c:pt>
                <c:pt idx="134">
                  <c:v>144</c:v>
                </c:pt>
                <c:pt idx="135">
                  <c:v>145</c:v>
                </c:pt>
                <c:pt idx="136">
                  <c:v>146</c:v>
                </c:pt>
                <c:pt idx="137">
                  <c:v>147</c:v>
                </c:pt>
                <c:pt idx="138">
                  <c:v>148</c:v>
                </c:pt>
                <c:pt idx="139">
                  <c:v>149</c:v>
                </c:pt>
              </c:numCache>
            </c:numRef>
          </c:xVal>
          <c:yVal>
            <c:numRef>
              <c:f>hq!$C$10:$C$149</c:f>
              <c:numCache>
                <c:formatCode>General</c:formatCode>
                <c:ptCount val="140"/>
                <c:pt idx="0">
                  <c:v>5677372</c:v>
                </c:pt>
                <c:pt idx="1">
                  <c:v>4586563</c:v>
                </c:pt>
                <c:pt idx="2">
                  <c:v>3857951</c:v>
                </c:pt>
                <c:pt idx="3">
                  <c:v>3290063</c:v>
                </c:pt>
                <c:pt idx="4">
                  <c:v>2864588</c:v>
                </c:pt>
                <c:pt idx="5">
                  <c:v>2533811</c:v>
                </c:pt>
                <c:pt idx="6">
                  <c:v>2281658</c:v>
                </c:pt>
                <c:pt idx="7">
                  <c:v>2080488</c:v>
                </c:pt>
                <c:pt idx="8">
                  <c:v>1917501</c:v>
                </c:pt>
                <c:pt idx="9">
                  <c:v>1785692</c:v>
                </c:pt>
                <c:pt idx="10">
                  <c:v>1672761</c:v>
                </c:pt>
                <c:pt idx="11">
                  <c:v>1581018</c:v>
                </c:pt>
                <c:pt idx="12">
                  <c:v>1497554</c:v>
                </c:pt>
                <c:pt idx="13">
                  <c:v>1419262</c:v>
                </c:pt>
                <c:pt idx="14">
                  <c:v>1350670</c:v>
                </c:pt>
                <c:pt idx="15">
                  <c:v>1291228</c:v>
                </c:pt>
                <c:pt idx="16">
                  <c:v>1231731</c:v>
                </c:pt>
                <c:pt idx="17">
                  <c:v>1184811</c:v>
                </c:pt>
                <c:pt idx="18">
                  <c:v>1140800</c:v>
                </c:pt>
                <c:pt idx="19">
                  <c:v>1099606</c:v>
                </c:pt>
                <c:pt idx="20">
                  <c:v>1068775</c:v>
                </c:pt>
                <c:pt idx="21">
                  <c:v>1032790</c:v>
                </c:pt>
                <c:pt idx="22">
                  <c:v>1000856</c:v>
                </c:pt>
                <c:pt idx="23">
                  <c:v>972864</c:v>
                </c:pt>
                <c:pt idx="24">
                  <c:v>942678</c:v>
                </c:pt>
                <c:pt idx="25">
                  <c:v>918486</c:v>
                </c:pt>
                <c:pt idx="26">
                  <c:v>894002</c:v>
                </c:pt>
                <c:pt idx="27">
                  <c:v>871254</c:v>
                </c:pt>
                <c:pt idx="28">
                  <c:v>846997</c:v>
                </c:pt>
                <c:pt idx="29">
                  <c:v>828227</c:v>
                </c:pt>
                <c:pt idx="30">
                  <c:v>809081</c:v>
                </c:pt>
                <c:pt idx="31">
                  <c:v>795629</c:v>
                </c:pt>
                <c:pt idx="32">
                  <c:v>782559</c:v>
                </c:pt>
                <c:pt idx="33">
                  <c:v>771942</c:v>
                </c:pt>
                <c:pt idx="34">
                  <c:v>763275</c:v>
                </c:pt>
                <c:pt idx="35">
                  <c:v>764869</c:v>
                </c:pt>
                <c:pt idx="36">
                  <c:v>767602</c:v>
                </c:pt>
                <c:pt idx="37">
                  <c:v>771790</c:v>
                </c:pt>
                <c:pt idx="38">
                  <c:v>777119</c:v>
                </c:pt>
                <c:pt idx="39">
                  <c:v>790816</c:v>
                </c:pt>
                <c:pt idx="40">
                  <c:v>807284</c:v>
                </c:pt>
                <c:pt idx="41">
                  <c:v>831341</c:v>
                </c:pt>
                <c:pt idx="42">
                  <c:v>859713</c:v>
                </c:pt>
                <c:pt idx="43">
                  <c:v>895773</c:v>
                </c:pt>
                <c:pt idx="44">
                  <c:v>934867</c:v>
                </c:pt>
                <c:pt idx="45">
                  <c:v>981231</c:v>
                </c:pt>
                <c:pt idx="46">
                  <c:v>1037692</c:v>
                </c:pt>
                <c:pt idx="47">
                  <c:v>1098928</c:v>
                </c:pt>
                <c:pt idx="48">
                  <c:v>1171584</c:v>
                </c:pt>
                <c:pt idx="49">
                  <c:v>1254933</c:v>
                </c:pt>
                <c:pt idx="50">
                  <c:v>1349594</c:v>
                </c:pt>
                <c:pt idx="51">
                  <c:v>1453322</c:v>
                </c:pt>
                <c:pt idx="52">
                  <c:v>1572547</c:v>
                </c:pt>
                <c:pt idx="53">
                  <c:v>1698716</c:v>
                </c:pt>
                <c:pt idx="54">
                  <c:v>1833915</c:v>
                </c:pt>
                <c:pt idx="55">
                  <c:v>1982285</c:v>
                </c:pt>
                <c:pt idx="56">
                  <c:v>2148179</c:v>
                </c:pt>
                <c:pt idx="57">
                  <c:v>2317576</c:v>
                </c:pt>
                <c:pt idx="58">
                  <c:v>2500325</c:v>
                </c:pt>
                <c:pt idx="59">
                  <c:v>2692699</c:v>
                </c:pt>
                <c:pt idx="60">
                  <c:v>2888802</c:v>
                </c:pt>
                <c:pt idx="61">
                  <c:v>3096469</c:v>
                </c:pt>
                <c:pt idx="62">
                  <c:v>3303004</c:v>
                </c:pt>
                <c:pt idx="63">
                  <c:v>3510595</c:v>
                </c:pt>
                <c:pt idx="64">
                  <c:v>3720976</c:v>
                </c:pt>
                <c:pt idx="65">
                  <c:v>3917860</c:v>
                </c:pt>
                <c:pt idx="66">
                  <c:v>4118554</c:v>
                </c:pt>
                <c:pt idx="67">
                  <c:v>4305710</c:v>
                </c:pt>
                <c:pt idx="68">
                  <c:v>4488661</c:v>
                </c:pt>
                <c:pt idx="69">
                  <c:v>4659253</c:v>
                </c:pt>
                <c:pt idx="70">
                  <c:v>4804556</c:v>
                </c:pt>
                <c:pt idx="71">
                  <c:v>4926867</c:v>
                </c:pt>
                <c:pt idx="72">
                  <c:v>5033500</c:v>
                </c:pt>
                <c:pt idx="73">
                  <c:v>5118964</c:v>
                </c:pt>
                <c:pt idx="74">
                  <c:v>5180414</c:v>
                </c:pt>
                <c:pt idx="75">
                  <c:v>5216306</c:v>
                </c:pt>
                <c:pt idx="76">
                  <c:v>5225969</c:v>
                </c:pt>
                <c:pt idx="77">
                  <c:v>5220637</c:v>
                </c:pt>
                <c:pt idx="78">
                  <c:v>5176335</c:v>
                </c:pt>
                <c:pt idx="79">
                  <c:v>5119982</c:v>
                </c:pt>
                <c:pt idx="80">
                  <c:v>5037726</c:v>
                </c:pt>
                <c:pt idx="81">
                  <c:v>4934286</c:v>
                </c:pt>
                <c:pt idx="82">
                  <c:v>4804134</c:v>
                </c:pt>
                <c:pt idx="83">
                  <c:v>4667777</c:v>
                </c:pt>
                <c:pt idx="84">
                  <c:v>4503400</c:v>
                </c:pt>
                <c:pt idx="85">
                  <c:v>4333026</c:v>
                </c:pt>
                <c:pt idx="86">
                  <c:v>4154445</c:v>
                </c:pt>
                <c:pt idx="87">
                  <c:v>3960643</c:v>
                </c:pt>
                <c:pt idx="88">
                  <c:v>3761236</c:v>
                </c:pt>
                <c:pt idx="89">
                  <c:v>3551841</c:v>
                </c:pt>
                <c:pt idx="90">
                  <c:v>3351975</c:v>
                </c:pt>
                <c:pt idx="91">
                  <c:v>3146577</c:v>
                </c:pt>
                <c:pt idx="92">
                  <c:v>2946424</c:v>
                </c:pt>
                <c:pt idx="93">
                  <c:v>2745033</c:v>
                </c:pt>
                <c:pt idx="94">
                  <c:v>2553047</c:v>
                </c:pt>
                <c:pt idx="95">
                  <c:v>2361295</c:v>
                </c:pt>
                <c:pt idx="96">
                  <c:v>2180420</c:v>
                </c:pt>
                <c:pt idx="97">
                  <c:v>2006281</c:v>
                </c:pt>
                <c:pt idx="98">
                  <c:v>1841618</c:v>
                </c:pt>
                <c:pt idx="99">
                  <c:v>1685503</c:v>
                </c:pt>
                <c:pt idx="100">
                  <c:v>1537487</c:v>
                </c:pt>
                <c:pt idx="101">
                  <c:v>1398935</c:v>
                </c:pt>
                <c:pt idx="102">
                  <c:v>1270993</c:v>
                </c:pt>
                <c:pt idx="103">
                  <c:v>1153230</c:v>
                </c:pt>
                <c:pt idx="104">
                  <c:v>1042819</c:v>
                </c:pt>
                <c:pt idx="105">
                  <c:v>942498</c:v>
                </c:pt>
                <c:pt idx="106">
                  <c:v>849976</c:v>
                </c:pt>
                <c:pt idx="107">
                  <c:v>765526</c:v>
                </c:pt>
                <c:pt idx="108">
                  <c:v>689947</c:v>
                </c:pt>
                <c:pt idx="109">
                  <c:v>620539</c:v>
                </c:pt>
                <c:pt idx="110">
                  <c:v>559325</c:v>
                </c:pt>
                <c:pt idx="111">
                  <c:v>505479</c:v>
                </c:pt>
                <c:pt idx="112">
                  <c:v>453903</c:v>
                </c:pt>
                <c:pt idx="113">
                  <c:v>410603</c:v>
                </c:pt>
                <c:pt idx="114">
                  <c:v>373688</c:v>
                </c:pt>
                <c:pt idx="115">
                  <c:v>338817</c:v>
                </c:pt>
                <c:pt idx="116">
                  <c:v>307565</c:v>
                </c:pt>
                <c:pt idx="117">
                  <c:v>280522</c:v>
                </c:pt>
                <c:pt idx="118">
                  <c:v>256781</c:v>
                </c:pt>
                <c:pt idx="119">
                  <c:v>238067</c:v>
                </c:pt>
                <c:pt idx="120">
                  <c:v>219571</c:v>
                </c:pt>
                <c:pt idx="121">
                  <c:v>204806</c:v>
                </c:pt>
                <c:pt idx="122">
                  <c:v>192501</c:v>
                </c:pt>
                <c:pt idx="123">
                  <c:v>181687</c:v>
                </c:pt>
                <c:pt idx="124">
                  <c:v>171249</c:v>
                </c:pt>
                <c:pt idx="125">
                  <c:v>164478</c:v>
                </c:pt>
                <c:pt idx="126">
                  <c:v>157887</c:v>
                </c:pt>
                <c:pt idx="127">
                  <c:v>151433</c:v>
                </c:pt>
                <c:pt idx="128">
                  <c:v>147401</c:v>
                </c:pt>
                <c:pt idx="129">
                  <c:v>143828</c:v>
                </c:pt>
                <c:pt idx="130">
                  <c:v>140666</c:v>
                </c:pt>
                <c:pt idx="131">
                  <c:v>137835</c:v>
                </c:pt>
                <c:pt idx="132">
                  <c:v>136702</c:v>
                </c:pt>
                <c:pt idx="133">
                  <c:v>135898</c:v>
                </c:pt>
                <c:pt idx="134">
                  <c:v>136225</c:v>
                </c:pt>
                <c:pt idx="135">
                  <c:v>135493</c:v>
                </c:pt>
                <c:pt idx="136">
                  <c:v>135567</c:v>
                </c:pt>
                <c:pt idx="137">
                  <c:v>136498</c:v>
                </c:pt>
                <c:pt idx="138">
                  <c:v>136319</c:v>
                </c:pt>
                <c:pt idx="139">
                  <c:v>13885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BB45-4E2B-974B-C6B13A58366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46033336"/>
        <c:axId val="646027760"/>
      </c:scatterChart>
      <c:valAx>
        <c:axId val="646033336"/>
        <c:scaling>
          <c:orientation val="minMax"/>
          <c:max val="16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46027760"/>
        <c:crosses val="autoZero"/>
        <c:crossBetween val="midCat"/>
        <c:majorUnit val="20"/>
      </c:valAx>
      <c:valAx>
        <c:axId val="64602776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46033336"/>
        <c:crosses val="autoZero"/>
        <c:crossBetween val="midCat"/>
        <c:dispUnits>
          <c:builtInUnit val="millions"/>
        </c:dispUnits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409DB46-E7C1-4421-A3B2-2FA1AD31C2A6}" type="datetimeFigureOut">
              <a:rPr lang="zh-CN" altLang="en-US" smtClean="0"/>
              <a:t>2020-10-2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7E52965-E488-4911-93CC-ACB1379A60A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088494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7E52965-E488-4911-93CC-ACB1379A60A0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46943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F7478F-4F29-4238-B87C-1F409380C779}" type="datetimeFigureOut">
              <a:rPr lang="zh-CN" altLang="en-US" smtClean="0"/>
              <a:t>2020-10-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337A8-A029-42DC-BC01-793C2A36CD3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97308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F7478F-4F29-4238-B87C-1F409380C779}" type="datetimeFigureOut">
              <a:rPr lang="zh-CN" altLang="en-US" smtClean="0"/>
              <a:t>2020-10-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337A8-A029-42DC-BC01-793C2A36CD3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16760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F7478F-4F29-4238-B87C-1F409380C779}" type="datetimeFigureOut">
              <a:rPr lang="zh-CN" altLang="en-US" smtClean="0"/>
              <a:t>2020-10-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337A8-A029-42DC-BC01-793C2A36CD3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114686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F7478F-4F29-4238-B87C-1F409380C779}" type="datetimeFigureOut">
              <a:rPr lang="zh-CN" altLang="en-US" smtClean="0"/>
              <a:t>2020-10-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337A8-A029-42DC-BC01-793C2A36CD3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975274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F7478F-4F29-4238-B87C-1F409380C779}" type="datetimeFigureOut">
              <a:rPr lang="zh-CN" altLang="en-US" smtClean="0"/>
              <a:t>2020-10-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337A8-A029-42DC-BC01-793C2A36CD3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71312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F7478F-4F29-4238-B87C-1F409380C779}" type="datetimeFigureOut">
              <a:rPr lang="zh-CN" altLang="en-US" smtClean="0"/>
              <a:t>2020-10-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337A8-A029-42DC-BC01-793C2A36CD3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91097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F7478F-4F29-4238-B87C-1F409380C779}" type="datetimeFigureOut">
              <a:rPr lang="zh-CN" altLang="en-US" smtClean="0"/>
              <a:t>2020-10-2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337A8-A029-42DC-BC01-793C2A36CD3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36227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F7478F-4F29-4238-B87C-1F409380C779}" type="datetimeFigureOut">
              <a:rPr lang="zh-CN" altLang="en-US" smtClean="0"/>
              <a:t>2020-10-2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337A8-A029-42DC-BC01-793C2A36CD3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8252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F7478F-4F29-4238-B87C-1F409380C779}" type="datetimeFigureOut">
              <a:rPr lang="zh-CN" altLang="en-US" smtClean="0"/>
              <a:t>2020-10-2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337A8-A029-42DC-BC01-793C2A36CD3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17751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F7478F-4F29-4238-B87C-1F409380C779}" type="datetimeFigureOut">
              <a:rPr lang="zh-CN" altLang="en-US" smtClean="0"/>
              <a:t>2020-10-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337A8-A029-42DC-BC01-793C2A36CD3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388240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F7478F-4F29-4238-B87C-1F409380C779}" type="datetimeFigureOut">
              <a:rPr lang="zh-CN" altLang="en-US" smtClean="0"/>
              <a:t>2020-10-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337A8-A029-42DC-BC01-793C2A36CD3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91408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F7478F-4F29-4238-B87C-1F409380C779}" type="datetimeFigureOut">
              <a:rPr lang="zh-CN" altLang="en-US" smtClean="0"/>
              <a:t>2020-10-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9337A8-A029-42DC-BC01-793C2A36CD3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601709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6BD530B1-58C1-430E-BD0B-236B20797141}"/>
              </a:ext>
            </a:extLst>
          </p:cNvPr>
          <p:cNvSpPr txBox="1"/>
          <p:nvPr/>
        </p:nvSpPr>
        <p:spPr>
          <a:xfrm>
            <a:off x="2145499" y="61405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3" name="组合 32">
            <a:extLst>
              <a:ext uri="{FF2B5EF4-FFF2-40B4-BE49-F238E27FC236}">
                <a16:creationId xmlns:a16="http://schemas.microsoft.com/office/drawing/2014/main" id="{472C1ADB-C13B-4458-9658-F9D6E719B2FF}"/>
              </a:ext>
            </a:extLst>
          </p:cNvPr>
          <p:cNvGrpSpPr/>
          <p:nvPr/>
        </p:nvGrpSpPr>
        <p:grpSpPr>
          <a:xfrm>
            <a:off x="2502592" y="786901"/>
            <a:ext cx="3975260" cy="2723399"/>
            <a:chOff x="2528326" y="703469"/>
            <a:chExt cx="3975260" cy="2723399"/>
          </a:xfrm>
        </p:grpSpPr>
        <p:pic>
          <p:nvPicPr>
            <p:cNvPr id="18" name="图片 17">
              <a:extLst>
                <a:ext uri="{FF2B5EF4-FFF2-40B4-BE49-F238E27FC236}">
                  <a16:creationId xmlns:a16="http://schemas.microsoft.com/office/drawing/2014/main" id="{9EDB2CCA-4931-499C-B4A7-1482B097928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5104" t="5833" r="33862" b="58469"/>
            <a:stretch/>
          </p:blipFill>
          <p:spPr>
            <a:xfrm>
              <a:off x="2591349" y="714411"/>
              <a:ext cx="3528529" cy="2712457"/>
            </a:xfrm>
            <a:prstGeom prst="rect">
              <a:avLst/>
            </a:prstGeom>
          </p:spPr>
        </p:pic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46E32020-7DB3-42DA-BEBC-F5427C15DEAE}"/>
                </a:ext>
              </a:extLst>
            </p:cNvPr>
            <p:cNvSpPr txBox="1"/>
            <p:nvPr/>
          </p:nvSpPr>
          <p:spPr>
            <a:xfrm>
              <a:off x="5153376" y="955524"/>
              <a:ext cx="51809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>
                <a:defRPr sz="12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altLang="zh-CN" sz="900" b="0" dirty="0">
                  <a:latin typeface="Arial" panose="020B0604020202020204" pitchFamily="34" charset="0"/>
                  <a:cs typeface="Arial" panose="020B0604020202020204" pitchFamily="34" charset="0"/>
                </a:rPr>
                <a:t>Debris</a:t>
              </a:r>
              <a:endParaRPr lang="zh-CN" altLang="en-US" sz="9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2BDDBEA8-C856-43C6-83BD-1CAD3331A5B4}"/>
                </a:ext>
              </a:extLst>
            </p:cNvPr>
            <p:cNvSpPr txBox="1"/>
            <p:nvPr/>
          </p:nvSpPr>
          <p:spPr>
            <a:xfrm>
              <a:off x="5145522" y="1105675"/>
              <a:ext cx="135806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>
                <a:defRPr sz="12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altLang="zh-CN" sz="900" b="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cutellaria</a:t>
              </a:r>
              <a:r>
                <a:rPr lang="en-US" altLang="zh-CN" sz="900" b="0" i="1" dirty="0">
                  <a:latin typeface="Arial" panose="020B0604020202020204" pitchFamily="34" charset="0"/>
                  <a:cs typeface="Arial" panose="020B0604020202020204" pitchFamily="34" charset="0"/>
                </a:rPr>
                <a:t> baicalensis </a:t>
              </a:r>
              <a:endParaRPr lang="zh-CN" altLang="en-US" sz="900" b="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C565B793-527B-4954-B194-44D5D3B3409B}"/>
                </a:ext>
              </a:extLst>
            </p:cNvPr>
            <p:cNvSpPr txBox="1"/>
            <p:nvPr/>
          </p:nvSpPr>
          <p:spPr>
            <a:xfrm>
              <a:off x="5153376" y="1241633"/>
              <a:ext cx="108876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>
                <a:defRPr sz="12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altLang="zh-CN" sz="900" b="0" i="1" dirty="0">
                  <a:latin typeface="Arial" panose="020B0604020202020204" pitchFamily="34" charset="0"/>
                  <a:cs typeface="Arial" panose="020B0604020202020204" pitchFamily="34" charset="0"/>
                </a:rPr>
                <a:t>Salvia </a:t>
              </a:r>
              <a:r>
                <a:rPr lang="en-US" altLang="zh-CN" sz="900" b="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iltiorrhiza</a:t>
              </a:r>
              <a:endParaRPr lang="zh-CN" altLang="en-US" sz="900" b="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" name="矩形 2">
              <a:extLst>
                <a:ext uri="{FF2B5EF4-FFF2-40B4-BE49-F238E27FC236}">
                  <a16:creationId xmlns:a16="http://schemas.microsoft.com/office/drawing/2014/main" id="{D570F82B-4516-4C2C-AD48-B3AADA000889}"/>
                </a:ext>
              </a:extLst>
            </p:cNvPr>
            <p:cNvSpPr/>
            <p:nvPr/>
          </p:nvSpPr>
          <p:spPr>
            <a:xfrm>
              <a:off x="2722669" y="2369820"/>
              <a:ext cx="131021" cy="1905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2" name="矩形 21">
              <a:extLst>
                <a:ext uri="{FF2B5EF4-FFF2-40B4-BE49-F238E27FC236}">
                  <a16:creationId xmlns:a16="http://schemas.microsoft.com/office/drawing/2014/main" id="{7D7F8AE6-4271-461C-942C-04D853302D3B}"/>
                </a:ext>
              </a:extLst>
            </p:cNvPr>
            <p:cNvSpPr/>
            <p:nvPr/>
          </p:nvSpPr>
          <p:spPr>
            <a:xfrm>
              <a:off x="2722668" y="1810752"/>
              <a:ext cx="131021" cy="1905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3" name="矩形 22">
              <a:extLst>
                <a:ext uri="{FF2B5EF4-FFF2-40B4-BE49-F238E27FC236}">
                  <a16:creationId xmlns:a16="http://schemas.microsoft.com/office/drawing/2014/main" id="{854140BB-5383-49CF-A1BC-C39967542E19}"/>
                </a:ext>
              </a:extLst>
            </p:cNvPr>
            <p:cNvSpPr/>
            <p:nvPr/>
          </p:nvSpPr>
          <p:spPr>
            <a:xfrm>
              <a:off x="2722667" y="1251538"/>
              <a:ext cx="131021" cy="1905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4" name="矩形 23">
              <a:extLst>
                <a:ext uri="{FF2B5EF4-FFF2-40B4-BE49-F238E27FC236}">
                  <a16:creationId xmlns:a16="http://schemas.microsoft.com/office/drawing/2014/main" id="{ABBDA197-61DD-4514-8F0A-E397696E3BBB}"/>
                </a:ext>
              </a:extLst>
            </p:cNvPr>
            <p:cNvSpPr/>
            <p:nvPr/>
          </p:nvSpPr>
          <p:spPr>
            <a:xfrm>
              <a:off x="2722666" y="703469"/>
              <a:ext cx="131021" cy="1905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5" name="矩形 24">
              <a:extLst>
                <a:ext uri="{FF2B5EF4-FFF2-40B4-BE49-F238E27FC236}">
                  <a16:creationId xmlns:a16="http://schemas.microsoft.com/office/drawing/2014/main" id="{4BDF439B-BAEF-4236-9DC1-370DCFC19935}"/>
                </a:ext>
              </a:extLst>
            </p:cNvPr>
            <p:cNvSpPr/>
            <p:nvPr/>
          </p:nvSpPr>
          <p:spPr>
            <a:xfrm>
              <a:off x="2722666" y="2914079"/>
              <a:ext cx="131021" cy="1905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A559702F-1407-494C-9538-25C5C236F5C3}"/>
                </a:ext>
              </a:extLst>
            </p:cNvPr>
            <p:cNvSpPr txBox="1"/>
            <p:nvPr/>
          </p:nvSpPr>
          <p:spPr>
            <a:xfrm>
              <a:off x="2640067" y="2385398"/>
              <a:ext cx="33374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D5C8BA7F-3A70-4458-8B93-2B3011605818}"/>
                </a:ext>
              </a:extLst>
            </p:cNvPr>
            <p:cNvSpPr txBox="1"/>
            <p:nvPr/>
          </p:nvSpPr>
          <p:spPr>
            <a:xfrm>
              <a:off x="2640067" y="1844827"/>
              <a:ext cx="33374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C1327B96-B43F-40DA-A0D2-FB9A0E745474}"/>
                </a:ext>
              </a:extLst>
            </p:cNvPr>
            <p:cNvSpPr txBox="1"/>
            <p:nvPr/>
          </p:nvSpPr>
          <p:spPr>
            <a:xfrm>
              <a:off x="2640067" y="1289087"/>
              <a:ext cx="33374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300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53082830-B87F-4A13-B539-110BDFE4AA93}"/>
                </a:ext>
              </a:extLst>
            </p:cNvPr>
            <p:cNvSpPr txBox="1"/>
            <p:nvPr/>
          </p:nvSpPr>
          <p:spPr>
            <a:xfrm>
              <a:off x="2640067" y="740529"/>
              <a:ext cx="33374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400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02C75878-6871-42BA-8325-5B657D8EA8DF}"/>
                </a:ext>
              </a:extLst>
            </p:cNvPr>
            <p:cNvSpPr txBox="1"/>
            <p:nvPr/>
          </p:nvSpPr>
          <p:spPr>
            <a:xfrm rot="16200000">
              <a:off x="2200291" y="1877316"/>
              <a:ext cx="856125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Number of nuclei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4" name="矩形 33">
            <a:extLst>
              <a:ext uri="{FF2B5EF4-FFF2-40B4-BE49-F238E27FC236}">
                <a16:creationId xmlns:a16="http://schemas.microsoft.com/office/drawing/2014/main" id="{292E6955-D36E-4D95-BBE4-9AC5447C4289}"/>
              </a:ext>
            </a:extLst>
          </p:cNvPr>
          <p:cNvSpPr/>
          <p:nvPr/>
        </p:nvSpPr>
        <p:spPr>
          <a:xfrm>
            <a:off x="5155692" y="2997512"/>
            <a:ext cx="655320" cy="1905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5" name="矩形 34">
            <a:extLst>
              <a:ext uri="{FF2B5EF4-FFF2-40B4-BE49-F238E27FC236}">
                <a16:creationId xmlns:a16="http://schemas.microsoft.com/office/drawing/2014/main" id="{A60F7EF9-046D-49E2-9F7F-A3C30AA022D4}"/>
              </a:ext>
            </a:extLst>
          </p:cNvPr>
          <p:cNvSpPr/>
          <p:nvPr/>
        </p:nvSpPr>
        <p:spPr>
          <a:xfrm>
            <a:off x="5520242" y="3188011"/>
            <a:ext cx="278578" cy="1905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31" name="直接连接符 30">
            <a:extLst>
              <a:ext uri="{FF2B5EF4-FFF2-40B4-BE49-F238E27FC236}">
                <a16:creationId xmlns:a16="http://schemas.microsoft.com/office/drawing/2014/main" id="{90BBCBA9-E755-47CE-8AB0-224B1F1D01E3}"/>
              </a:ext>
            </a:extLst>
          </p:cNvPr>
          <p:cNvCxnSpPr/>
          <p:nvPr/>
        </p:nvCxnSpPr>
        <p:spPr>
          <a:xfrm>
            <a:off x="5320215" y="4284958"/>
            <a:ext cx="199534" cy="0"/>
          </a:xfrm>
          <a:prstGeom prst="line">
            <a:avLst/>
          </a:prstGeom>
          <a:ln w="28575">
            <a:solidFill>
              <a:srgbClr val="5B9BD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文本框 7">
            <a:extLst>
              <a:ext uri="{FF2B5EF4-FFF2-40B4-BE49-F238E27FC236}">
                <a16:creationId xmlns:a16="http://schemas.microsoft.com/office/drawing/2014/main" id="{13A679D8-8A70-4D56-BD21-9705C018B460}"/>
              </a:ext>
            </a:extLst>
          </p:cNvPr>
          <p:cNvSpPr txBox="1"/>
          <p:nvPr/>
        </p:nvSpPr>
        <p:spPr>
          <a:xfrm>
            <a:off x="5504400" y="4155350"/>
            <a:ext cx="13580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b="0" i="1" dirty="0" err="1">
                <a:latin typeface="Arial" panose="020B0604020202020204" pitchFamily="34" charset="0"/>
                <a:cs typeface="Arial" panose="020B0604020202020204" pitchFamily="34" charset="0"/>
              </a:rPr>
              <a:t>Scutellaria</a:t>
            </a:r>
            <a:r>
              <a:rPr lang="en-US" altLang="zh-CN" sz="900" b="0" i="1" dirty="0">
                <a:latin typeface="Arial" panose="020B0604020202020204" pitchFamily="34" charset="0"/>
                <a:cs typeface="Arial" panose="020B0604020202020204" pitchFamily="34" charset="0"/>
              </a:rPr>
              <a:t> baicalensis </a:t>
            </a:r>
            <a:endParaRPr lang="zh-CN" altLang="en-US" sz="900" b="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F35081C8-BF08-4885-82A5-540F794CADA6}"/>
              </a:ext>
            </a:extLst>
          </p:cNvPr>
          <p:cNvCxnSpPr/>
          <p:nvPr/>
        </p:nvCxnSpPr>
        <p:spPr>
          <a:xfrm>
            <a:off x="5327889" y="4484037"/>
            <a:ext cx="199534" cy="0"/>
          </a:xfrm>
          <a:prstGeom prst="line">
            <a:avLst/>
          </a:prstGeom>
          <a:ln w="28575">
            <a:solidFill>
              <a:srgbClr val="ED7D3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文本框 9">
            <a:extLst>
              <a:ext uri="{FF2B5EF4-FFF2-40B4-BE49-F238E27FC236}">
                <a16:creationId xmlns:a16="http://schemas.microsoft.com/office/drawing/2014/main" id="{33891DFB-D646-451F-9304-A07F27504FE3}"/>
              </a:ext>
            </a:extLst>
          </p:cNvPr>
          <p:cNvSpPr txBox="1"/>
          <p:nvPr/>
        </p:nvSpPr>
        <p:spPr>
          <a:xfrm>
            <a:off x="5519747" y="4354429"/>
            <a:ext cx="117852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b="0" i="1" dirty="0" err="1">
                <a:latin typeface="Arial" panose="020B0604020202020204" pitchFamily="34" charset="0"/>
                <a:cs typeface="Arial" panose="020B0604020202020204" pitchFamily="34" charset="0"/>
              </a:rPr>
              <a:t>Scutellaria</a:t>
            </a:r>
            <a:r>
              <a:rPr lang="en-US" altLang="zh-CN" sz="900" b="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900" b="0" i="1" dirty="0" err="1">
                <a:latin typeface="Arial" panose="020B0604020202020204" pitchFamily="34" charset="0"/>
                <a:cs typeface="Arial" panose="020B0604020202020204" pitchFamily="34" charset="0"/>
              </a:rPr>
              <a:t>barbata</a:t>
            </a:r>
            <a:r>
              <a:rPr lang="en-US" altLang="zh-CN" sz="900" b="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900" b="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11">
            <a:extLst>
              <a:ext uri="{FF2B5EF4-FFF2-40B4-BE49-F238E27FC236}">
                <a16:creationId xmlns:a16="http://schemas.microsoft.com/office/drawing/2014/main" id="{6690804E-0F75-4503-B237-31165DAF1F73}"/>
              </a:ext>
            </a:extLst>
          </p:cNvPr>
          <p:cNvSpPr txBox="1"/>
          <p:nvPr/>
        </p:nvSpPr>
        <p:spPr>
          <a:xfrm>
            <a:off x="3575970" y="5953358"/>
            <a:ext cx="20409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i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zh-CN" sz="900" dirty="0" err="1">
                <a:latin typeface="Arial" panose="020B0604020202020204" pitchFamily="34" charset="0"/>
                <a:cs typeface="Arial" panose="020B0604020202020204" pitchFamily="34" charset="0"/>
              </a:rPr>
              <a:t>mer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coverage 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depth  (</a:t>
            </a:r>
            <a:r>
              <a:rPr lang="en-US" altLang="zh-CN" sz="900" i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zh-CN" sz="900" dirty="0" err="1">
                <a:latin typeface="Arial" panose="020B0604020202020204" pitchFamily="34" charset="0"/>
                <a:cs typeface="Arial" panose="020B0604020202020204" pitchFamily="34" charset="0"/>
              </a:rPr>
              <a:t>mer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= 21)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12">
            <a:extLst>
              <a:ext uri="{FF2B5EF4-FFF2-40B4-BE49-F238E27FC236}">
                <a16:creationId xmlns:a16="http://schemas.microsoft.com/office/drawing/2014/main" id="{6B75F7FC-6713-45C7-B5BF-53BD97ED73C4}"/>
              </a:ext>
            </a:extLst>
          </p:cNvPr>
          <p:cNvSpPr txBox="1"/>
          <p:nvPr/>
        </p:nvSpPr>
        <p:spPr>
          <a:xfrm rot="16200000">
            <a:off x="2067690" y="4832049"/>
            <a:ext cx="101021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Frequency (10</a:t>
            </a:r>
            <a:r>
              <a:rPr lang="en-US" altLang="zh-CN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13">
            <a:extLst>
              <a:ext uri="{FF2B5EF4-FFF2-40B4-BE49-F238E27FC236}">
                <a16:creationId xmlns:a16="http://schemas.microsoft.com/office/drawing/2014/main" id="{40DF56E7-A0E5-4B9A-9ADF-46A0C06AED2B}"/>
              </a:ext>
            </a:extLst>
          </p:cNvPr>
          <p:cNvSpPr txBox="1"/>
          <p:nvPr/>
        </p:nvSpPr>
        <p:spPr>
          <a:xfrm>
            <a:off x="2145499" y="360699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76509DA8-46A0-4403-A77C-5086C3A14A82}"/>
              </a:ext>
            </a:extLst>
          </p:cNvPr>
          <p:cNvCxnSpPr/>
          <p:nvPr/>
        </p:nvCxnSpPr>
        <p:spPr>
          <a:xfrm flipV="1">
            <a:off x="3596195" y="4711306"/>
            <a:ext cx="65561" cy="164071"/>
          </a:xfrm>
          <a:prstGeom prst="line">
            <a:avLst/>
          </a:prstGeom>
          <a:ln w="1905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矩形 42">
            <a:extLst>
              <a:ext uri="{FF2B5EF4-FFF2-40B4-BE49-F238E27FC236}">
                <a16:creationId xmlns:a16="http://schemas.microsoft.com/office/drawing/2014/main" id="{19017D7C-0BA2-448C-9A26-B9CC7E581C1D}"/>
              </a:ext>
            </a:extLst>
          </p:cNvPr>
          <p:cNvSpPr/>
          <p:nvPr/>
        </p:nvSpPr>
        <p:spPr>
          <a:xfrm>
            <a:off x="3294106" y="4501692"/>
            <a:ext cx="94769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Heterozygosity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4" name="图表 43">
            <a:extLst>
              <a:ext uri="{FF2B5EF4-FFF2-40B4-BE49-F238E27FC236}">
                <a16:creationId xmlns:a16="http://schemas.microsoft.com/office/drawing/2014/main" id="{80C560B5-D950-445A-91E8-D2229058370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48597765"/>
              </p:ext>
            </p:extLst>
          </p:nvPr>
        </p:nvGraphicFramePr>
        <p:xfrm>
          <a:off x="2696932" y="3958179"/>
          <a:ext cx="3722077" cy="20758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15648098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88</TotalTime>
  <Words>32</Words>
  <Application>Microsoft Office PowerPoint</Application>
  <PresentationFormat>全屏显示(4:3)</PresentationFormat>
  <Paragraphs>16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ichao Xu</dc:creator>
  <cp:lastModifiedBy>焦玉霞</cp:lastModifiedBy>
  <cp:revision>12</cp:revision>
  <dcterms:created xsi:type="dcterms:W3CDTF">2020-02-20T12:55:18Z</dcterms:created>
  <dcterms:modified xsi:type="dcterms:W3CDTF">2020-10-20T10:28:04Z</dcterms:modified>
</cp:coreProperties>
</file>